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BA0CF6-E169-4941-97D2-51722F804F6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99F0D9-998B-4F34-9E56-48CDF85725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119D5F-70F2-41E1-94E6-EA0F2AD7723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F45A92-E8FB-4A52-A03E-E3DE8FCF331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EFDE77-3775-4223-A5B9-C1BE4C6A19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09465B-95C5-41EC-AB68-309C34B5E0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C681F1-6A4E-4E4D-BC67-6B2AFE79DB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78D187-E23B-4601-88A9-2AE5C05B25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BFF636-089E-490F-8DA0-94FF5CC2DE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474FB2-ADA2-4933-B18F-97C77AF2AC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784F1E-3349-47DF-B2F6-00B30818FD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AA2B17-DF80-49EB-917B-43BE57683A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5C5AC50-5371-4670-A098-04986A634E1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jpeg"/><Relationship Id="rId3" Type="http://schemas.openxmlformats.org/officeDocument/2006/relationships/image" Target="../media/image7.jpeg"/><Relationship Id="rId4" Type="http://schemas.openxmlformats.org/officeDocument/2006/relationships/image" Target="../media/image8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5" descr="pate-1"/>
          <p:cNvPicPr/>
          <p:nvPr/>
        </p:nvPicPr>
        <p:blipFill>
          <a:blip r:embed="rId1"/>
          <a:srcRect l="7587" t="0" r="50002" b="0"/>
          <a:stretch/>
        </p:blipFill>
        <p:spPr>
          <a:xfrm>
            <a:off x="380880" y="1447920"/>
            <a:ext cx="2422800" cy="384804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10" descr="pate-2"/>
          <p:cNvPicPr/>
          <p:nvPr/>
        </p:nvPicPr>
        <p:blipFill>
          <a:blip r:embed="rId2"/>
          <a:srcRect l="5092" t="8026" r="35033" b="16670"/>
          <a:stretch/>
        </p:blipFill>
        <p:spPr>
          <a:xfrm>
            <a:off x="2971800" y="1676520"/>
            <a:ext cx="3886200" cy="32922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11" descr="pate-3"/>
          <p:cNvPicPr/>
          <p:nvPr/>
        </p:nvPicPr>
        <p:blipFill>
          <a:blip r:embed="rId3"/>
          <a:srcRect l="4263" t="10493" r="34200" b="17900"/>
          <a:stretch/>
        </p:blipFill>
        <p:spPr>
          <a:xfrm>
            <a:off x="0" y="5391000"/>
            <a:ext cx="3962520" cy="310536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12" descr="pate-4"/>
          <p:cNvPicPr/>
          <p:nvPr/>
        </p:nvPicPr>
        <p:blipFill>
          <a:blip r:embed="rId4"/>
          <a:srcRect l="2597" t="0" r="49004" b="16670"/>
          <a:stretch/>
        </p:blipFill>
        <p:spPr>
          <a:xfrm>
            <a:off x="3276720" y="5029200"/>
            <a:ext cx="3581280" cy="4152960"/>
          </a:xfrm>
          <a:prstGeom prst="rect">
            <a:avLst/>
          </a:prstGeom>
          <a:ln w="0">
            <a:noFill/>
          </a:ln>
        </p:spPr>
      </p:pic>
      <p:sp>
        <p:nvSpPr>
          <p:cNvPr id="45" name="Text Box 13"/>
          <p:cNvSpPr/>
          <p:nvPr/>
        </p:nvSpPr>
        <p:spPr>
          <a:xfrm>
            <a:off x="441720" y="420840"/>
            <a:ext cx="59490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2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AT PATE THREE DIMENSIONA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TRUCTURE SHOWN IN DIFFERENT ORIENTAT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8" descr="pate-f 4"/>
          <p:cNvPicPr/>
          <p:nvPr/>
        </p:nvPicPr>
        <p:blipFill>
          <a:blip r:embed="rId1"/>
          <a:srcRect l="15904" t="19137" r="19232" b="22840"/>
          <a:stretch/>
        </p:blipFill>
        <p:spPr>
          <a:xfrm>
            <a:off x="3505320" y="6081840"/>
            <a:ext cx="3429000" cy="2066760"/>
          </a:xfrm>
          <a:prstGeom prst="rect">
            <a:avLst/>
          </a:prstGeom>
          <a:ln w="0">
            <a:noFill/>
          </a:ln>
        </p:spPr>
      </p:pic>
      <p:sp>
        <p:nvSpPr>
          <p:cNvPr id="47" name="Text Box 4"/>
          <p:cNvSpPr/>
          <p:nvPr/>
        </p:nvSpPr>
        <p:spPr>
          <a:xfrm>
            <a:off x="594000" y="1030320"/>
            <a:ext cx="5949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AT PATE –F THREE DIMENSIONA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TRUCTURE SHOWN IN DIFFERENT ORIENTAT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Picture 5" descr="pate-f 1"/>
          <p:cNvPicPr/>
          <p:nvPr/>
        </p:nvPicPr>
        <p:blipFill>
          <a:blip r:embed="rId2"/>
          <a:srcRect l="20893" t="1855" r="32538" b="4322"/>
          <a:stretch/>
        </p:blipFill>
        <p:spPr>
          <a:xfrm>
            <a:off x="276120" y="2133720"/>
            <a:ext cx="2695680" cy="365760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6" descr="pate-f 2"/>
          <p:cNvPicPr/>
          <p:nvPr/>
        </p:nvPicPr>
        <p:blipFill>
          <a:blip r:embed="rId3"/>
          <a:srcRect l="16737" t="11729" r="18399" b="12966"/>
          <a:stretch/>
        </p:blipFill>
        <p:spPr>
          <a:xfrm>
            <a:off x="2895480" y="2514600"/>
            <a:ext cx="3962520" cy="309888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7" descr="pate-f 3"/>
          <p:cNvPicPr/>
          <p:nvPr/>
        </p:nvPicPr>
        <p:blipFill>
          <a:blip r:embed="rId4"/>
          <a:srcRect l="22115" t="16670" r="19232" b="17900"/>
          <a:stretch/>
        </p:blipFill>
        <p:spPr>
          <a:xfrm>
            <a:off x="-76320" y="5557680"/>
            <a:ext cx="3657600" cy="2748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18T09:35:47Z</dcterms:created>
  <dc:creator>Dr. SURESH</dc:creator>
  <dc:description/>
  <dc:language>en-US</dc:language>
  <cp:lastModifiedBy>suresh</cp:lastModifiedBy>
  <dcterms:modified xsi:type="dcterms:W3CDTF">2012-02-10T01:12:56Z</dcterms:modified>
  <cp:revision>12</cp:revision>
  <dc:subject/>
  <dc:title>Slide 1</dc:title>
</cp:coreProperties>
</file>